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2" d="100"/>
          <a:sy n="62" d="100"/>
        </p:scale>
        <p:origin x="35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w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w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A93530-45E7-4197-80ED-A02538EB97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BAA6EBC-4377-4426-A33B-F0909E3AE14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F6EC83-2D1D-4456-988F-A1F1D40B59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FF3C-17EA-4955-946E-4257769F49C0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01A23C-9FC6-44A9-89C4-ABC35ED160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C748B1-A3FB-4A0C-88C6-836C7DB96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8A07D-0C8E-41DC-B437-6B2BFEC3F8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374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F75770-9D21-456F-BBD5-B82DA9985E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C04436-A04A-49B0-BD69-92BF31979C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84F27C-715F-4E51-8978-8DAF0CC1A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FF3C-17EA-4955-946E-4257769F49C0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75FA62-6E8E-4FD3-BB42-A702561CFF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C489F7-BA6D-4E4B-A1D5-FCB795718F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8A07D-0C8E-41DC-B437-6B2BFEC3F8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967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9E57C3F-6F74-4A25-8817-7A4DD2121F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36C6CF-52B4-4D12-B092-5052E6A50B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6704BB-35AC-4CBF-8BB6-E8B7CFCD4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FF3C-17EA-4955-946E-4257769F49C0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DF7497-0F2B-40A0-BF82-B5562EC327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FF79E9-6C99-4E94-85F3-B8280BADC2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8A07D-0C8E-41DC-B437-6B2BFEC3F8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18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901B6A-B899-470A-BDA7-2677B39E2F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056E51-C559-4884-91DD-ABC4342C3A5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4B1E73-0F79-4C6E-9B3E-437DB49AB8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FF3C-17EA-4955-946E-4257769F49C0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5D2558-1B2E-45DC-B469-BDB4C051E0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CBB484-887D-4106-9A8D-D65A207ADB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8A07D-0C8E-41DC-B437-6B2BFEC3F8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4781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6639AB-3B28-4E8F-9930-E4F6046E61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AF61C2-8CF4-43D2-8111-1E767FE5F7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BEE840-E4D3-4139-94C5-B0157263C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FF3C-17EA-4955-946E-4257769F49C0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8EF0B5-E566-4FE2-B602-A9AED3F3C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17138A-01F0-4CE1-9D2B-B20FB99F13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8A07D-0C8E-41DC-B437-6B2BFEC3F8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620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56C715-E67B-48F8-BA7E-406016FEA9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E93B62-0A09-4170-9D47-32C4313A60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A140C8-347F-464B-ABD1-4E2B5D1C54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653A12-AB3D-4E19-8764-8BF562F02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FF3C-17EA-4955-946E-4257769F49C0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00FAA9-C283-4CBA-A3D0-0B2FD72DF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EEF224-C983-4D09-A8C2-1F18DED6B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8A07D-0C8E-41DC-B437-6B2BFEC3F8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286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FDCDF4-66A1-4BE7-B1EE-705E92F87F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CD4961-C186-4227-8F40-789EF55A44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205AA9-A9FC-451E-A735-D064B7EA03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CB5AA4-1B21-422D-91E5-0F193D0A60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A022E16-1334-4433-8102-AB58CF0B2D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8807A73-5CD5-4197-A630-0B9103D7AE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FF3C-17EA-4955-946E-4257769F49C0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5F02B59-E4F7-4B0D-B354-E67D57A4B2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156D34F-FF27-45A8-B8AF-420F30394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8A07D-0C8E-41DC-B437-6B2BFEC3F8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382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D8348E-F7D5-4F97-8CFD-2AB83BD71F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20902DE-2402-4556-8DF3-95C1C00316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FF3C-17EA-4955-946E-4257769F49C0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DED8E78-8EA5-4A8B-B7BE-1A13A47CB9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BFA910D-8864-459A-AA37-DC8887AD15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8A07D-0C8E-41DC-B437-6B2BFEC3F8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5090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915264B-DCB1-41A5-A535-60C3C35942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FF3C-17EA-4955-946E-4257769F49C0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05F2CCF-7ED6-4E73-BD03-E5A10D073E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09274AE-520C-46C7-83BF-0FD7BB16A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8A07D-0C8E-41DC-B437-6B2BFEC3F8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6503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1116D4-E80F-4470-B6C6-9A719E61AF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3A5C5C-9DB1-4F45-891A-ABAD6B953E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22E5602-FE81-4293-A8A3-A9057DBE24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4C14FC-5BC3-416D-B45D-414B5FC592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FF3C-17EA-4955-946E-4257769F49C0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69E0FB-7362-4ACF-A6F2-B26027C1E3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2C6B22-D01E-47EB-9D25-5AEE61E7E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8A07D-0C8E-41DC-B437-6B2BFEC3F8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432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13FAE9-CBD0-42E2-B08E-6B483DC65B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340FF36-7DC0-4239-90D2-4A1AD75E39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D1C8ED-BC7C-4441-A03A-1E7E9A8CE8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D7D458-7CA4-4687-8ECD-16A4B8C072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FF3C-17EA-4955-946E-4257769F49C0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A4183E-6447-4325-A123-B06887A26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25E712-A10F-4EA1-B547-236D16358D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8A07D-0C8E-41DC-B437-6B2BFEC3F8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369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5F6687E-4E4C-4D67-A4F4-81C56505D1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182885-8289-453A-8155-271C3A0602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D3CD00-7F02-463F-AF12-FF478FA070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5FF3C-17EA-4955-946E-4257769F49C0}" type="datetimeFigureOut">
              <a:rPr lang="en-US" smtClean="0"/>
              <a:t>3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DC903D-97E7-4BF7-9DBF-23CE7EBF64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575552-4CE7-4211-AA7D-8FD074AFEE2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88A07D-0C8E-41DC-B437-6B2BFEC3F8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42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w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4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26A19167-7EBB-43C2-AE5D-423CA63C9A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6757059"/>
              </p:ext>
            </p:extLst>
          </p:nvPr>
        </p:nvGraphicFramePr>
        <p:xfrm>
          <a:off x="3000054" y="1351166"/>
          <a:ext cx="6499069" cy="4864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0" r:id="rId3" imgW="2417040" imgH="1810440" progId="">
                  <p:embed/>
                </p:oleObj>
              </mc:Choice>
              <mc:Fallback>
                <p:oleObj r:id="rId3" imgW="2417040" imgH="18104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000054" y="1351166"/>
                        <a:ext cx="6499069" cy="4864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01BB580-ADE4-422B-901A-87730101E595}"/>
              </a:ext>
            </a:extLst>
          </p:cNvPr>
          <p:cNvSpPr txBox="1"/>
          <p:nvPr/>
        </p:nvSpPr>
        <p:spPr>
          <a:xfrm>
            <a:off x="3123343" y="852756"/>
            <a:ext cx="24144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estern blot for </a:t>
            </a:r>
            <a:r>
              <a:rPr lang="en-US" dirty="0" err="1"/>
              <a:t>pAK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689236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42906E79-BDF1-4E21-BD7C-6A3C7FFB0D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2399475"/>
              </p:ext>
            </p:extLst>
          </p:nvPr>
        </p:nvGraphicFramePr>
        <p:xfrm>
          <a:off x="3015736" y="844035"/>
          <a:ext cx="6400114" cy="47890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r:id="rId3" imgW="7567920" imgH="5663160" progId="">
                  <p:embed/>
                </p:oleObj>
              </mc:Choice>
              <mc:Fallback>
                <p:oleObj r:id="rId3" imgW="7567920" imgH="566316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015736" y="844035"/>
                        <a:ext cx="6400114" cy="47890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286871D2-24A4-4BCB-B324-78A402662E11}"/>
              </a:ext>
            </a:extLst>
          </p:cNvPr>
          <p:cNvSpPr txBox="1"/>
          <p:nvPr/>
        </p:nvSpPr>
        <p:spPr>
          <a:xfrm>
            <a:off x="3123343" y="476257"/>
            <a:ext cx="24144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estern blot for pp38</a:t>
            </a:r>
          </a:p>
        </p:txBody>
      </p:sp>
    </p:spTree>
    <p:extLst>
      <p:ext uri="{BB962C8B-B14F-4D97-AF65-F5344CB8AC3E}">
        <p14:creationId xmlns:p14="http://schemas.microsoft.com/office/powerpoint/2010/main" val="35504068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5AE44C61-2F23-49A9-B4D9-EC36BC9A76F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8189232"/>
              </p:ext>
            </p:extLst>
          </p:nvPr>
        </p:nvGraphicFramePr>
        <p:xfrm>
          <a:off x="2930525" y="1087120"/>
          <a:ext cx="6532323" cy="48953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3" r:id="rId3" imgW="15822000" imgH="11872800" progId="">
                  <p:embed/>
                </p:oleObj>
              </mc:Choice>
              <mc:Fallback>
                <p:oleObj r:id="rId3" imgW="15822000" imgH="118728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30525" y="1087120"/>
                        <a:ext cx="6532323" cy="48953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6E665F55-C221-4592-8FD5-332CDBE48F9E}"/>
              </a:ext>
            </a:extLst>
          </p:cNvPr>
          <p:cNvSpPr txBox="1"/>
          <p:nvPr/>
        </p:nvSpPr>
        <p:spPr>
          <a:xfrm>
            <a:off x="3082247" y="549557"/>
            <a:ext cx="24144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estern blot for </a:t>
            </a:r>
            <a:r>
              <a:rPr lang="en-US" dirty="0" err="1"/>
              <a:t>pJNK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523244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179385B-E7E1-486C-B270-30F20137CE7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1107759"/>
              </p:ext>
            </p:extLst>
          </p:nvPr>
        </p:nvGraphicFramePr>
        <p:xfrm>
          <a:off x="3457574" y="1522797"/>
          <a:ext cx="5605146" cy="41709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7" r:id="rId3" imgW="2432160" imgH="1810440" progId="">
                  <p:embed/>
                </p:oleObj>
              </mc:Choice>
              <mc:Fallback>
                <p:oleObj r:id="rId3" imgW="2432160" imgH="18104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57574" y="1522797"/>
                        <a:ext cx="5605146" cy="41709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F810B17-1551-4692-9D87-9F0CEA4E8912}"/>
              </a:ext>
            </a:extLst>
          </p:cNvPr>
          <p:cNvSpPr txBox="1"/>
          <p:nvPr/>
        </p:nvSpPr>
        <p:spPr>
          <a:xfrm>
            <a:off x="3457574" y="904127"/>
            <a:ext cx="29726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estern blot for GAPDH</a:t>
            </a:r>
          </a:p>
        </p:txBody>
      </p:sp>
    </p:spTree>
    <p:extLst>
      <p:ext uri="{BB962C8B-B14F-4D97-AF65-F5344CB8AC3E}">
        <p14:creationId xmlns:p14="http://schemas.microsoft.com/office/powerpoint/2010/main" val="29021168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6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i, Laijun</dc:creator>
  <cp:lastModifiedBy>Lai, Laijun</cp:lastModifiedBy>
  <cp:revision>3</cp:revision>
  <dcterms:created xsi:type="dcterms:W3CDTF">2021-01-05T16:08:35Z</dcterms:created>
  <dcterms:modified xsi:type="dcterms:W3CDTF">2021-03-05T15:05:23Z</dcterms:modified>
</cp:coreProperties>
</file>